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4668914-734A-F588-4C2E-AD37DA8B2E13}" name="Anthony Swain" initials="AS" userId="Anthony Swain" providerId="None"/>
  <p188:author id="{8F4F1484-770B-D90B-A95A-C4CCDCB84F04}" name="Writer" initials="Wr" userId="Writer" providerId="None"/>
  <p188:author id="{AFA94493-2206-2E36-DD95-4B723C247387}" name="Tanaka Yuichi(田中 優一)" initials="T優" userId="S::tanaka.yuichi@taiho.co.jp::9fd23434-910d-4269-8c82-491110d3666f" providerId="AD"/>
  <p188:author id="{FB44D097-B8F4-EB14-799F-B63E448D40A4}" name="eps" initials="eps" userId="eps" providerId="None"/>
  <p188:author id="{627C629F-4D24-3C47-D6FE-41FA12D837D7}" name="Nishimura Yuko(西村　祐子)" initials="NY" userId="S::y-nishimura@taiho.co.jp::525a77d6-9eaf-4ccd-8266-d71b81c28f64" providerId="AD"/>
  <p188:author id="{0E3396CF-7702-91D3-C346-1B4B41B26550}" name="Sarah Bubeck" initials="SB" userId="Sarah Bubeck" providerId="None"/>
  <p188:author id="{C94C16D6-97F8-BB90-F298-BBF24B590414}" name="Keyra Martinez Dunn" initials="KMD" userId="Keyra Martinez Dunn" providerId="None"/>
  <p188:author id="{0900F7D8-3AF9-EAF8-3EBE-1B2094BDE866}" name="Hideki Maikuma" initials="MH" userId="Hideki Maikuma" providerId="None"/>
  <p188:author id="{A1F459DB-2A04-7A3B-3328-209695FB7293}" name="Lin Donghu(林　東虎)" initials="LD" userId="S::dh-lin@taiho.co.jp::a832fa63-eb14-4e11-9fc2-2c5e61b96a3b" providerId="AD"/>
  <p188:author id="{92E77FE4-0A86-95F8-AD72-F132E0E6B4E1}" name="Keyra Martinez Dunn" initials="KMD" userId="b63def9f560e7e7e" providerId="Windows Live"/>
  <p188:author id="{426582E5-9FE0-B9EE-7AF5-69D810E1BCCB}" name="Nasermoaddeli Ari(モアッデリ　アリ)" initials="NA" userId="S::a-moaddeli@taiho.co.jp::1d197918-55ab-4163-828a-4597ef6fa8f4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FFF00"/>
    <a:srgbClr val="00B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>
        <p:scale>
          <a:sx n="100" d="100"/>
          <a:sy n="100" d="100"/>
        </p:scale>
        <p:origin x="954" y="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8/10/relationships/authors" Target="authors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9E7CAB-01D1-71EA-3AA9-08B4B9714F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51EB36-EB4D-1819-1E19-152033453A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24A7F8-4665-17F9-8465-5020A49B3E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03F82-3ED1-44D0-8B2D-7F2F3E6DE6C7}" type="datetimeFigureOut">
              <a:rPr lang="en-US" smtClean="0"/>
              <a:t>7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308A42-2F23-EDEC-0DFE-92FE1BCA6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9ECAE8-C7EC-FD5E-1A91-76644F4E5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5DBEF-D86F-4068-9BD8-FF4CFA12D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864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ACD682-E558-0940-2DB9-261E43167D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98A4A78-8A1E-AC2D-09A9-B656C49D53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560F60-3EB8-5414-10E4-EB1B42F43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03F82-3ED1-44D0-8B2D-7F2F3E6DE6C7}" type="datetimeFigureOut">
              <a:rPr lang="en-US" smtClean="0"/>
              <a:t>7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27F66D-59B8-615A-ABAE-ACF3B7B536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A781B0-E2B0-8EBB-E669-FA3A8C432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5DBEF-D86F-4068-9BD8-FF4CFA12D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011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E5FA7AF-FADA-50C8-2BAF-EFA1774D4DB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5F270B-6E40-F56C-8D4B-CA41A37A4E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B9A886-BD12-77E7-3C5F-EFCBE70A9D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03F82-3ED1-44D0-8B2D-7F2F3E6DE6C7}" type="datetimeFigureOut">
              <a:rPr lang="en-US" smtClean="0"/>
              <a:t>7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A0B8F4-6966-5E35-6B7B-5DE000E10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D4D6A-A34E-613F-1A7F-5200C5210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5DBEF-D86F-4068-9BD8-FF4CFA12D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805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FAD63E-8D90-21A6-DE51-8CADAA08A8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D2AEB1-F8A0-8A5A-D7E2-8EDAAB88F3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0E73DB-8452-E745-617E-7B9BCB1B67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03F82-3ED1-44D0-8B2D-7F2F3E6DE6C7}" type="datetimeFigureOut">
              <a:rPr lang="en-US" smtClean="0"/>
              <a:t>7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6F044A-D4BE-DDF5-B04D-FFE7221DC7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AB17F9-9138-824C-2A31-E5A67B12FD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5DBEF-D86F-4068-9BD8-FF4CFA12D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099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F57234-C660-A28D-165E-217C6989B7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ADCCF1-2019-E374-B519-58B8530CC7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FB3405-D643-7D58-41CB-1F423ABB4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03F82-3ED1-44D0-8B2D-7F2F3E6DE6C7}" type="datetimeFigureOut">
              <a:rPr lang="en-US" smtClean="0"/>
              <a:t>7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24272E-9BD5-0017-22C9-744D93EF55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A86C40-D10B-8EA4-05EB-178B71803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5DBEF-D86F-4068-9BD8-FF4CFA12D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128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477C82-D773-84DB-4271-60A5EE10E1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09AF24-84EA-A521-274B-4BFF5C3664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07D1CD-0559-ADFE-7DFA-C2153B9CE3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81FC81-13E8-66AB-2379-0B8AC5AC2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03F82-3ED1-44D0-8B2D-7F2F3E6DE6C7}" type="datetimeFigureOut">
              <a:rPr lang="en-US" smtClean="0"/>
              <a:t>7/1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341392-92D8-A323-856F-3D39F4BA7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D5F33E-6659-1900-7555-91A67CF31B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5DBEF-D86F-4068-9BD8-FF4CFA12D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613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6265DB-DC17-642D-8AD8-EB70C386D2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0A27AC-9A0D-3E5B-C80B-116B5946BB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498A53-1E6C-4B60-668C-7FAB643C54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089049-C452-D4B8-3ACB-7BC05362FD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014A893-0D07-25B6-374C-99BC8D0C04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65701F0-E5E3-2A16-86E1-FB11C68969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03F82-3ED1-44D0-8B2D-7F2F3E6DE6C7}" type="datetimeFigureOut">
              <a:rPr lang="en-US" smtClean="0"/>
              <a:t>7/1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94C2BC-3767-D036-DDAB-9B1F19F7FA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2AF6ACC-4BDD-10B0-B4CA-A516FEA00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5DBEF-D86F-4068-9BD8-FF4CFA12D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307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870EE9-8A48-B538-329F-6C2E75B78D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B6E6C4C-094B-C86B-1FF1-6B2FE0FF5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03F82-3ED1-44D0-8B2D-7F2F3E6DE6C7}" type="datetimeFigureOut">
              <a:rPr lang="en-US" smtClean="0"/>
              <a:t>7/1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CB32BF2-4D7A-141B-785C-B4BBFC1FE7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8AF5E7D-22CB-EF00-ABF9-23C1DCB6C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5DBEF-D86F-4068-9BD8-FF4CFA12D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7781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D098E03-0ADC-9508-3D35-05104D9AA1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03F82-3ED1-44D0-8B2D-7F2F3E6DE6C7}" type="datetimeFigureOut">
              <a:rPr lang="en-US" smtClean="0"/>
              <a:t>7/1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A8DAA3C-5890-6236-E52E-5099AEC4CF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E58357-ADD7-71DC-6493-E08E2A07A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5DBEF-D86F-4068-9BD8-FF4CFA12D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3857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2BA038-73E0-FDC5-5FCB-229A315AA2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86C6E1-99F4-1890-0E24-2E1A4F8BCF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4ED174-684F-701E-AAEC-8896BAD6E1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28B0FC-5819-558F-A1E8-2A387154F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03F82-3ED1-44D0-8B2D-7F2F3E6DE6C7}" type="datetimeFigureOut">
              <a:rPr lang="en-US" smtClean="0"/>
              <a:t>7/1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3662CD-D422-2FC3-06C2-9404A3B6BF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CEFC75-C27E-DE50-5CCC-4FFBC3CE7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5DBEF-D86F-4068-9BD8-FF4CFA12D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749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49A75D-F05A-47F2-71E0-0A9F40F021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6BABED7-D240-A4E5-322E-441A762DA9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B46978-6BD4-876E-3C54-9FDEA21B86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3A8CDD-3A7E-F5FB-8F6B-1F965242F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803F82-3ED1-44D0-8B2D-7F2F3E6DE6C7}" type="datetimeFigureOut">
              <a:rPr lang="en-US" smtClean="0"/>
              <a:t>7/1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F5E1D8-E7FA-9490-3875-33334BF10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4F9A74-E510-B374-6A4E-63681B921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5DBEF-D86F-4068-9BD8-FF4CFA12D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1904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105B1A7-3693-4A39-19AF-0D3D5342A5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E6E81F-AF66-B88B-9E35-BA02DBD585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1C00BE-E987-4218-DB59-C9C27D68D1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803F82-3ED1-44D0-8B2D-7F2F3E6DE6C7}" type="datetimeFigureOut">
              <a:rPr lang="en-US" smtClean="0"/>
              <a:t>7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DD0E90-A454-5774-BF13-93B98DC98A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4A4D88-192E-73F8-2433-15DAE9C244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C5DBEF-D86F-4068-9BD8-FF4CFA12D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034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13E4BA52-C3C4-5505-9D93-2AABC1C19162}"/>
              </a:ext>
            </a:extLst>
          </p:cNvPr>
          <p:cNvSpPr/>
          <p:nvPr/>
        </p:nvSpPr>
        <p:spPr>
          <a:xfrm>
            <a:off x="714090" y="3469015"/>
            <a:ext cx="1450268" cy="91956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se level 1</a:t>
            </a:r>
          </a:p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 mg QD</a:t>
            </a:r>
          </a:p>
          <a:p>
            <a:pPr algn="ctr"/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(treated)/N (enrolled) </a:t>
            </a:r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2/2</a:t>
            </a:r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E0142689-DAA6-9C4F-05C6-A64111815968}"/>
              </a:ext>
            </a:extLst>
          </p:cNvPr>
          <p:cNvSpPr/>
          <p:nvPr/>
        </p:nvSpPr>
        <p:spPr>
          <a:xfrm>
            <a:off x="3651352" y="1396803"/>
            <a:ext cx="1450268" cy="62082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se level 4</a:t>
            </a:r>
          </a:p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 mg QD</a:t>
            </a:r>
          </a:p>
          <a:p>
            <a:pPr algn="ctr"/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/N </a:t>
            </a:r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3/3</a:t>
            </a:r>
          </a:p>
        </p:txBody>
      </p: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B08E3F7F-FA1A-5CDC-5745-576873E05934}"/>
              </a:ext>
            </a:extLst>
          </p:cNvPr>
          <p:cNvSpPr/>
          <p:nvPr/>
        </p:nvSpPr>
        <p:spPr>
          <a:xfrm>
            <a:off x="2672778" y="2093133"/>
            <a:ext cx="1450268" cy="61667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se level 3</a:t>
            </a:r>
          </a:p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 mg QD</a:t>
            </a:r>
          </a:p>
          <a:p>
            <a:pPr algn="ctr"/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/N </a:t>
            </a:r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6/6</a:t>
            </a:r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A37EAB12-27A1-BE3F-6DFF-CD1AB088DF29}"/>
              </a:ext>
            </a:extLst>
          </p:cNvPr>
          <p:cNvSpPr/>
          <p:nvPr/>
        </p:nvSpPr>
        <p:spPr>
          <a:xfrm>
            <a:off x="1694576" y="2781074"/>
            <a:ext cx="1450268" cy="61667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se level 2</a:t>
            </a:r>
          </a:p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 mg QD</a:t>
            </a:r>
          </a:p>
          <a:p>
            <a:pPr algn="ctr"/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/N </a:t>
            </a:r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1/1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33344C1D-5716-8828-3476-8D32E5B078F9}"/>
              </a:ext>
            </a:extLst>
          </p:cNvPr>
          <p:cNvCxnSpPr>
            <a:cxnSpLocks/>
          </p:cNvCxnSpPr>
          <p:nvPr/>
        </p:nvCxnSpPr>
        <p:spPr>
          <a:xfrm flipV="1">
            <a:off x="1439224" y="3083035"/>
            <a:ext cx="0" cy="3775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06744CCA-4477-372D-FACF-0BD8382CC087}"/>
              </a:ext>
            </a:extLst>
          </p:cNvPr>
          <p:cNvCxnSpPr/>
          <p:nvPr/>
        </p:nvCxnSpPr>
        <p:spPr>
          <a:xfrm>
            <a:off x="1439224" y="3083035"/>
            <a:ext cx="25535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16148392-084C-CF8A-934E-BBFE7DF3F5B6}"/>
              </a:ext>
            </a:extLst>
          </p:cNvPr>
          <p:cNvCxnSpPr>
            <a:cxnSpLocks/>
            <a:stCxn id="7" idx="0"/>
          </p:cNvCxnSpPr>
          <p:nvPr/>
        </p:nvCxnSpPr>
        <p:spPr>
          <a:xfrm flipH="1" flipV="1">
            <a:off x="2417426" y="2386705"/>
            <a:ext cx="2284" cy="3943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AA8874C2-8B61-B046-3271-F55DE14C128A}"/>
              </a:ext>
            </a:extLst>
          </p:cNvPr>
          <p:cNvCxnSpPr/>
          <p:nvPr/>
        </p:nvCxnSpPr>
        <p:spPr>
          <a:xfrm>
            <a:off x="2417426" y="2386705"/>
            <a:ext cx="25535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B4045C74-9B0A-7CB5-7D5D-0E041358D525}"/>
              </a:ext>
            </a:extLst>
          </p:cNvPr>
          <p:cNvCxnSpPr>
            <a:cxnSpLocks/>
            <a:stCxn id="6" idx="0"/>
          </p:cNvCxnSpPr>
          <p:nvPr/>
        </p:nvCxnSpPr>
        <p:spPr>
          <a:xfrm flipV="1">
            <a:off x="3397912" y="1698764"/>
            <a:ext cx="2096" cy="3943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20B726BB-CF5F-971F-C5AE-C53CF52B9096}"/>
              </a:ext>
            </a:extLst>
          </p:cNvPr>
          <p:cNvCxnSpPr/>
          <p:nvPr/>
        </p:nvCxnSpPr>
        <p:spPr>
          <a:xfrm>
            <a:off x="3400008" y="1698764"/>
            <a:ext cx="25535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EF047D7B-9CC3-FC80-3AD4-0F996E82D06B}"/>
              </a:ext>
            </a:extLst>
          </p:cNvPr>
          <p:cNvSpPr txBox="1"/>
          <p:nvPr/>
        </p:nvSpPr>
        <p:spPr>
          <a:xfrm>
            <a:off x="1912909" y="784053"/>
            <a:ext cx="211147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ose escalation phase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n/N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= 12/12)</a:t>
            </a:r>
          </a:p>
        </p:txBody>
      </p:sp>
      <p:sp>
        <p:nvSpPr>
          <p:cNvPr id="27" name="Rectangle: Rounded Corners 26">
            <a:extLst>
              <a:ext uri="{FF2B5EF4-FFF2-40B4-BE49-F238E27FC236}">
                <a16:creationId xmlns:a16="http://schemas.microsoft.com/office/drawing/2014/main" id="{547BB6FF-0355-311D-C215-9A275D20B7A6}"/>
              </a:ext>
            </a:extLst>
          </p:cNvPr>
          <p:cNvSpPr/>
          <p:nvPr/>
        </p:nvSpPr>
        <p:spPr>
          <a:xfrm>
            <a:off x="6010127" y="1707302"/>
            <a:ext cx="1766497" cy="827214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se level 4</a:t>
            </a:r>
          </a:p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 mg/day for 4 days on/3 days off</a:t>
            </a:r>
          </a:p>
          <a:p>
            <a:pPr algn="ctr"/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/N </a:t>
            </a:r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6/6</a:t>
            </a:r>
          </a:p>
        </p:txBody>
      </p:sp>
      <p:sp>
        <p:nvSpPr>
          <p:cNvPr id="30" name="Rectangle: Rounded Corners 29">
            <a:extLst>
              <a:ext uri="{FF2B5EF4-FFF2-40B4-BE49-F238E27FC236}">
                <a16:creationId xmlns:a16="http://schemas.microsoft.com/office/drawing/2014/main" id="{43DB575E-9A67-51A9-B89A-A5AEB2F92CA7}"/>
              </a:ext>
            </a:extLst>
          </p:cNvPr>
          <p:cNvSpPr/>
          <p:nvPr/>
        </p:nvSpPr>
        <p:spPr>
          <a:xfrm>
            <a:off x="6010127" y="2950134"/>
            <a:ext cx="1766497" cy="827214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se level 5</a:t>
            </a:r>
          </a:p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2 mg/day for 4 days on/3 days off</a:t>
            </a:r>
          </a:p>
          <a:p>
            <a:pPr algn="ctr"/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/N </a:t>
            </a:r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4/4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5A306D6-65BC-0243-4704-F652AE0010A2}"/>
              </a:ext>
            </a:extLst>
          </p:cNvPr>
          <p:cNvSpPr txBox="1"/>
          <p:nvPr/>
        </p:nvSpPr>
        <p:spPr>
          <a:xfrm>
            <a:off x="5583561" y="837197"/>
            <a:ext cx="261962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gimen modification phase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n/N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= 10/10)</a:t>
            </a:r>
          </a:p>
        </p:txBody>
      </p:sp>
      <p:sp>
        <p:nvSpPr>
          <p:cNvPr id="49" name="Rectangle: Rounded Corners 48">
            <a:extLst>
              <a:ext uri="{FF2B5EF4-FFF2-40B4-BE49-F238E27FC236}">
                <a16:creationId xmlns:a16="http://schemas.microsoft.com/office/drawing/2014/main" id="{E59382BD-521D-08D4-0D4A-F6314D094069}"/>
              </a:ext>
            </a:extLst>
          </p:cNvPr>
          <p:cNvSpPr/>
          <p:nvPr/>
        </p:nvSpPr>
        <p:spPr>
          <a:xfrm>
            <a:off x="8824647" y="2206533"/>
            <a:ext cx="2567603" cy="66057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hort 1</a:t>
            </a:r>
          </a:p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K3CA mut+ endometrial cancer</a:t>
            </a:r>
          </a:p>
          <a:p>
            <a:pPr algn="ctr"/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/N </a:t>
            </a:r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16/16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6134A9F-C643-94F5-6ABD-D0DE94EBA151}"/>
              </a:ext>
            </a:extLst>
          </p:cNvPr>
          <p:cNvSpPr txBox="1"/>
          <p:nvPr/>
        </p:nvSpPr>
        <p:spPr>
          <a:xfrm>
            <a:off x="8990995" y="837197"/>
            <a:ext cx="24112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afety assessment phase 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n/N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= 43/44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699C554-CBF5-160B-8ECB-CBE33BF0D098}"/>
              </a:ext>
            </a:extLst>
          </p:cNvPr>
          <p:cNvSpPr txBox="1"/>
          <p:nvPr/>
        </p:nvSpPr>
        <p:spPr>
          <a:xfrm>
            <a:off x="9175174" y="1386865"/>
            <a:ext cx="186654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se level 4</a:t>
            </a:r>
          </a:p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 mg/day for 4 days on/3 days off</a:t>
            </a:r>
          </a:p>
        </p:txBody>
      </p:sp>
      <p:sp>
        <p:nvSpPr>
          <p:cNvPr id="55" name="Rectangle: Rounded Corners 54">
            <a:extLst>
              <a:ext uri="{FF2B5EF4-FFF2-40B4-BE49-F238E27FC236}">
                <a16:creationId xmlns:a16="http://schemas.microsoft.com/office/drawing/2014/main" id="{DAAB76F3-8361-D1CF-B855-6F447E3A2D85}"/>
              </a:ext>
            </a:extLst>
          </p:cNvPr>
          <p:cNvSpPr/>
          <p:nvPr/>
        </p:nvSpPr>
        <p:spPr>
          <a:xfrm>
            <a:off x="8824647" y="2963554"/>
            <a:ext cx="2567603" cy="814769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hort 2</a:t>
            </a:r>
          </a:p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KT1 mut+ or AKT1/2 amplification+ endometrial cancer</a:t>
            </a:r>
          </a:p>
          <a:p>
            <a:pPr algn="ctr"/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/N </a:t>
            </a:r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7/7</a:t>
            </a:r>
          </a:p>
        </p:txBody>
      </p:sp>
      <p:sp>
        <p:nvSpPr>
          <p:cNvPr id="56" name="Rectangle: Rounded Corners 55">
            <a:extLst>
              <a:ext uri="{FF2B5EF4-FFF2-40B4-BE49-F238E27FC236}">
                <a16:creationId xmlns:a16="http://schemas.microsoft.com/office/drawing/2014/main" id="{7980369C-9E0C-D671-DCE3-4656545ACD08}"/>
              </a:ext>
            </a:extLst>
          </p:cNvPr>
          <p:cNvSpPr/>
          <p:nvPr/>
        </p:nvSpPr>
        <p:spPr>
          <a:xfrm>
            <a:off x="8824647" y="3880075"/>
            <a:ext cx="2567603" cy="66057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hort 3</a:t>
            </a:r>
          </a:p>
          <a:p>
            <a:pPr algn="ctr"/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arian clear cell carcinoma</a:t>
            </a:r>
          </a:p>
          <a:p>
            <a:pPr algn="ctr"/>
            <a:r>
              <a:rPr lang="en-US" sz="12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/N </a:t>
            </a:r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20/21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211B5ED-7E82-74A5-9883-A3713B25CC28}"/>
              </a:ext>
            </a:extLst>
          </p:cNvPr>
          <p:cNvSpPr txBox="1"/>
          <p:nvPr/>
        </p:nvSpPr>
        <p:spPr>
          <a:xfrm>
            <a:off x="278454" y="292873"/>
            <a:ext cx="18742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Supplemental Fig. 1</a:t>
            </a:r>
          </a:p>
        </p:txBody>
      </p:sp>
    </p:spTree>
    <p:extLst>
      <p:ext uri="{BB962C8B-B14F-4D97-AF65-F5344CB8AC3E}">
        <p14:creationId xmlns:p14="http://schemas.microsoft.com/office/powerpoint/2010/main" val="35915218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36D15B08931C904A93B3C01EC215AA23" ma:contentTypeVersion="4" ma:contentTypeDescription="新しいドキュメントを作成します。" ma:contentTypeScope="" ma:versionID="8ac982afe85a71dd760275c07d193957">
  <xsd:schema xmlns:xsd="http://www.w3.org/2001/XMLSchema" xmlns:xs="http://www.w3.org/2001/XMLSchema" xmlns:p="http://schemas.microsoft.com/office/2006/metadata/properties" xmlns:ns2="87feefd9-e61a-4d40-9fe8-34ae1c4ab22c" targetNamespace="http://schemas.microsoft.com/office/2006/metadata/properties" ma:root="true" ma:fieldsID="272183268ad7cbe5272f1f00c4fe689c" ns2:_="">
    <xsd:import namespace="87feefd9-e61a-4d40-9fe8-34ae1c4ab22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7feefd9-e61a-4d40-9fe8-34ae1c4ab22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1F24F8F-EA89-481B-9887-38891BEE2CC6}">
  <ds:schemaRefs>
    <ds:schemaRef ds:uri="78b900f6-a06c-4d65-9d90-3a2d8df09806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  <ds:schemaRef ds:uri="2ec5469a-d0a5-4233-9928-b53a20d4ce81"/>
    <ds:schemaRef ds:uri="495ab518-9bf8-46c0-9b0b-b664e8e97b72"/>
  </ds:schemaRefs>
</ds:datastoreItem>
</file>

<file path=customXml/itemProps2.xml><?xml version="1.0" encoding="utf-8"?>
<ds:datastoreItem xmlns:ds="http://schemas.openxmlformats.org/officeDocument/2006/customXml" ds:itemID="{A52B4553-D907-4E9E-BBF9-0133006A21E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46F5B6C-FF58-4C5A-BD59-BB0C54F0CA6A}"/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177</Words>
  <Application>Microsoft Office PowerPoint</Application>
  <PresentationFormat>ワイド画面</PresentationFormat>
  <Paragraphs>3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terms:created xsi:type="dcterms:W3CDTF">2022-12-13T17:28:28Z</dcterms:created>
  <dcterms:modified xsi:type="dcterms:W3CDTF">2023-07-18T08:48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6D15B08931C904A93B3C01EC215AA23</vt:lpwstr>
  </property>
  <property fmtid="{D5CDD505-2E9C-101B-9397-08002B2CF9AE}" pid="3" name="Order">
    <vt:r8>4800</vt:r8>
  </property>
  <property fmtid="{D5CDD505-2E9C-101B-9397-08002B2CF9AE}" pid="4" name="xd_Signature">
    <vt:bool>false</vt:bool>
  </property>
  <property fmtid="{D5CDD505-2E9C-101B-9397-08002B2CF9AE}" pid="5" name="xd_ProgID">
    <vt:lpwstr/>
  </property>
  <property fmtid="{D5CDD505-2E9C-101B-9397-08002B2CF9AE}" pid="6" name="_ExtendedDescription">
    <vt:lpwstr/>
  </property>
  <property fmtid="{D5CDD505-2E9C-101B-9397-08002B2CF9AE}" pid="7" name="TriggerFlowInfo">
    <vt:lpwstr/>
  </property>
  <property fmtid="{D5CDD505-2E9C-101B-9397-08002B2CF9AE}" pid="8" name="ComplianceAssetId">
    <vt:lpwstr/>
  </property>
  <property fmtid="{D5CDD505-2E9C-101B-9397-08002B2CF9AE}" pid="9" name="TemplateUrl">
    <vt:lpwstr/>
  </property>
</Properties>
</file>